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  <p:sldId id="262" r:id="rId3"/>
    <p:sldId id="264" r:id="rId4"/>
    <p:sldId id="265" r:id="rId5"/>
    <p:sldId id="263" r:id="rId6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327"/>
  </p:normalViewPr>
  <p:slideViewPr>
    <p:cSldViewPr snapToGrid="0">
      <p:cViewPr varScale="1">
        <p:scale>
          <a:sx n="111" d="100"/>
          <a:sy n="111" d="100"/>
        </p:scale>
        <p:origin x="6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C2F1AF-D5D9-01E1-946A-F92EDB3E7F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AFE6E59-64A6-1643-8DC9-390E9772A7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438990-6D51-7C4D-7524-3337E73651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9B269-9AB3-9841-AF8F-F717656E5C29}" type="datetimeFigureOut">
              <a:rPr lang="en-DE" smtClean="0"/>
              <a:t>11.03.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1FC6F9-912E-22A2-09C9-3D55590D2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B0E21B-6E6A-09CA-E876-FFA610F9BC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B64F-8584-B54F-BA5A-07E7418E825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827386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36D1B9-EC83-6E7A-7526-9FD50BC195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687DED-DC95-CFEC-00B0-F86D33A3B5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6693B8-FB78-DF6B-7D5D-2560ADD52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9B269-9AB3-9841-AF8F-F717656E5C29}" type="datetimeFigureOut">
              <a:rPr lang="en-DE" smtClean="0"/>
              <a:t>11.03.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A74CF5-DDF6-815C-CE4D-EEFCEC9853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E57183-EC96-D7C6-C9F1-05E1D37CA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B64F-8584-B54F-BA5A-07E7418E825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796819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5684871-C5BB-FFCF-9603-739B36F116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1A29AE-F130-7009-2E45-5D4BD68223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70A6D2-9AC9-E36D-2DD4-12EE0154D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9B269-9AB3-9841-AF8F-F717656E5C29}" type="datetimeFigureOut">
              <a:rPr lang="en-DE" smtClean="0"/>
              <a:t>11.03.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33A726-6ADF-499B-5886-263A9A47E8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B3800E-0189-8E12-C970-55D79568F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B64F-8584-B54F-BA5A-07E7418E825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673062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46A8E3-F09E-0D5F-A85E-49BEA33B52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EC26E1-03AC-D82E-2205-8AA058960E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17252B-1655-2C77-B5E2-AA677DA54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9B269-9AB3-9841-AF8F-F717656E5C29}" type="datetimeFigureOut">
              <a:rPr lang="en-DE" smtClean="0"/>
              <a:t>11.03.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1B8649-85CC-3D85-41CD-F1E701AD4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C966BE-4A41-46BB-9A05-F354888AB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B64F-8584-B54F-BA5A-07E7418E825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04370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9B8D6D-62AB-179E-5F55-A311075D57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96058F-74E1-539A-D596-E8B18EB3B9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1D68AE-2273-7569-9471-F5C91D978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9B269-9AB3-9841-AF8F-F717656E5C29}" type="datetimeFigureOut">
              <a:rPr lang="en-DE" smtClean="0"/>
              <a:t>11.03.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B3DE97-492D-82EE-A28C-242892A67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15620E-D3EC-BABD-86ED-E80B5DF18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B64F-8584-B54F-BA5A-07E7418E825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28615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472350-FD50-3EA9-7CBF-52312BF2CC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4EB2CC-15B8-7948-E410-138A54F307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3582D6-0A3F-530D-04C9-13FA321B5E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77AA3E-A6BE-294E-CAAF-BF04797C0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9B269-9AB3-9841-AF8F-F717656E5C29}" type="datetimeFigureOut">
              <a:rPr lang="en-DE" smtClean="0"/>
              <a:t>11.03.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4E108C-3859-FD44-F46D-C1345B23F9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521494-560B-5790-9FBF-9A5BCA86F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B64F-8584-B54F-BA5A-07E7418E825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863231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36DB8F-29B6-13AD-7E3A-AB5ED821E9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ADBCE6-3CB5-EF51-C34F-0E1B858C4F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F6180A-E71A-AC03-A4E6-19C5C6AC67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68F622E-6252-5AC8-9308-C8267BAB14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FFC079-B2C9-62E1-774D-EF9196C74E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A9002F4-1EA1-D6FA-C8BA-CD8393A57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9B269-9AB3-9841-AF8F-F717656E5C29}" type="datetimeFigureOut">
              <a:rPr lang="en-DE" smtClean="0"/>
              <a:t>11.03.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418B40A-E6B2-A4D1-00F0-A33673CB4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F85A0E9-4AE8-00B2-1F22-A77D5C396C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B64F-8584-B54F-BA5A-07E7418E825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09788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7CF0E3-F242-F558-CF52-48ED6C71C1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49EF078-0258-C002-D210-A26475CEB8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9B269-9AB3-9841-AF8F-F717656E5C29}" type="datetimeFigureOut">
              <a:rPr lang="en-DE" smtClean="0"/>
              <a:t>11.03.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E516837-4C02-3D1E-B305-CD9062517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2F38F1-592C-C259-97BB-94C228AF9A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B64F-8584-B54F-BA5A-07E7418E825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95851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800DAC-2ADE-6E27-5C6E-45973D7F3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9B269-9AB3-9841-AF8F-F717656E5C29}" type="datetimeFigureOut">
              <a:rPr lang="en-DE" smtClean="0"/>
              <a:t>11.03.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02398C9-AABC-5AD9-098B-00A95F643B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5332EDD-5ED5-470C-9222-6A4357FC6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B64F-8584-B54F-BA5A-07E7418E825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387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4A7B83-A65C-1D3D-A93F-1F5738CB5F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A31383-C22D-A0C4-1A23-6551177C4E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5089B2-2E03-E919-20DD-000F1C2BF1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F7664A-5208-29AB-6196-59D39B343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9B269-9AB3-9841-AF8F-F717656E5C29}" type="datetimeFigureOut">
              <a:rPr lang="en-DE" smtClean="0"/>
              <a:t>11.03.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CA76FC-B8A9-9A32-7F43-24FD1C77A8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E646E0-5563-9280-2A76-1685E79DB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B64F-8584-B54F-BA5A-07E7418E825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51135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DFAAD-31BF-94EE-4AAE-03680FCFDA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633FCC5-5757-6395-DF1F-E0F2E1214F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625D9F-862F-AFBA-77A7-2D8513A6AE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7CF2EA-B183-DAD2-3963-9C9BC5477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D9B269-9AB3-9841-AF8F-F717656E5C29}" type="datetimeFigureOut">
              <a:rPr lang="en-DE" smtClean="0"/>
              <a:t>11.03.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5746F3-63EE-FF99-2BC6-746BA16C5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0855B6-4F85-29B9-59CF-DA5C1946A5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F1B64F-8584-B54F-BA5A-07E7418E825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383636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2928AA-9945-B24E-DAA4-92889AE1DF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2024C6-552F-4B9B-965E-837DEA6356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9CCA1B-755E-5ACD-1B18-B3F2582F94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D9B269-9AB3-9841-AF8F-F717656E5C29}" type="datetimeFigureOut">
              <a:rPr lang="en-DE" smtClean="0"/>
              <a:t>11.03.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411C5F-A215-7245-0822-AC820DCBA7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77FB7B-CFFA-3149-8B9F-96EE254F5F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F1B64F-8584-B54F-BA5A-07E7418E8259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50438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63A07A0-4720-19DD-D236-9FF9FCDC65DD}"/>
              </a:ext>
            </a:extLst>
          </p:cNvPr>
          <p:cNvSpPr txBox="1"/>
          <p:nvPr/>
        </p:nvSpPr>
        <p:spPr>
          <a:xfrm>
            <a:off x="1336522" y="5833440"/>
            <a:ext cx="9595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UMAP plot of the training set (two-third split). Methodology and coloring is equivalent to Figure 2 of the manuscript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FEFAD8C-28C3-C484-7488-A67665F96F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798" y="879094"/>
            <a:ext cx="7772400" cy="47854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63668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E5A2CA3-F496-9FE5-FCFA-7ABC147967BE}"/>
              </a:ext>
            </a:extLst>
          </p:cNvPr>
          <p:cNvSpPr txBox="1"/>
          <p:nvPr/>
        </p:nvSpPr>
        <p:spPr>
          <a:xfrm>
            <a:off x="1255571" y="5838051"/>
            <a:ext cx="93249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UMAP plot of the test set (one-third split). Methodology and coloring is equivalent to Figure 2 of the manuscript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F3546A0-AD23-0185-4DBD-D1F7C0BC7F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1061024"/>
            <a:ext cx="7772400" cy="47359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06292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9AB4F18-9E28-0013-F11A-696F9981EC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742950"/>
            <a:ext cx="6858000" cy="4572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2F41102-8818-0E49-E9DB-164E94356E8C}"/>
              </a:ext>
            </a:extLst>
          </p:cNvPr>
          <p:cNvSpPr txBox="1"/>
          <p:nvPr/>
        </p:nvSpPr>
        <p:spPr>
          <a:xfrm>
            <a:off x="1116111" y="5838051"/>
            <a:ext cx="100880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Clustering of the reference cohort, displaying the first two principal components after principal component analysis (PCA). </a:t>
            </a:r>
          </a:p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Coloring is equivalent to Figure 2 of the manuscript.</a:t>
            </a:r>
          </a:p>
        </p:txBody>
      </p:sp>
    </p:spTree>
    <p:extLst>
      <p:ext uri="{BB962C8B-B14F-4D97-AF65-F5344CB8AC3E}">
        <p14:creationId xmlns:p14="http://schemas.microsoft.com/office/powerpoint/2010/main" val="27010801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648CA8E-8EAC-A627-8D4D-5BF210CC52F4}"/>
              </a:ext>
            </a:extLst>
          </p:cNvPr>
          <p:cNvSpPr txBox="1"/>
          <p:nvPr/>
        </p:nvSpPr>
        <p:spPr>
          <a:xfrm>
            <a:off x="2023988" y="5849625"/>
            <a:ext cx="81467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: t-SNE clustering of the reference cohort. Coloring is equivalent to Figure 2 of the manuscript.</a:t>
            </a:r>
          </a:p>
        </p:txBody>
      </p:sp>
      <p:pic>
        <p:nvPicPr>
          <p:cNvPr id="2" name="Picture 1" descr="A diagram of different colored dots&#10;&#10;Description automatically generated">
            <a:extLst>
              <a:ext uri="{FF2B5EF4-FFF2-40B4-BE49-F238E27FC236}">
                <a16:creationId xmlns:a16="http://schemas.microsoft.com/office/drawing/2014/main" id="{BD10892F-A1B2-AA7A-C723-8AF89F7C30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11229" y="760841"/>
            <a:ext cx="7737107" cy="50549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61534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60644A8-495B-CB60-E7AD-9226D9F9CBA3}"/>
              </a:ext>
            </a:extLst>
          </p:cNvPr>
          <p:cNvSpPr txBox="1"/>
          <p:nvPr/>
        </p:nvSpPr>
        <p:spPr>
          <a:xfrm>
            <a:off x="380333" y="5742011"/>
            <a:ext cx="114313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: UMAP clustering of the reference cohort with color indicating the centre, where methylation analysis was performed, and the array type used.</a:t>
            </a:r>
            <a:b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Methodology is equivalent to Figure 2 of the manuscript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F9774DB-3ECE-57CE-25BF-6919FAB83E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654324"/>
            <a:ext cx="7772400" cy="50864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6510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0</TotalTime>
  <Words>145</Words>
  <Application>Microsoft Macintosh PowerPoint</Application>
  <PresentationFormat>Widescreen</PresentationFormat>
  <Paragraphs>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onhard Stark</dc:creator>
  <cp:lastModifiedBy>Stark, Leonhard</cp:lastModifiedBy>
  <cp:revision>7</cp:revision>
  <dcterms:created xsi:type="dcterms:W3CDTF">2023-07-15T12:52:08Z</dcterms:created>
  <dcterms:modified xsi:type="dcterms:W3CDTF">2024-03-11T19:55:34Z</dcterms:modified>
</cp:coreProperties>
</file>